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10234613" cy="70993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Beatrice" initials="B" lastIdx="1" clrIdx="0"/>
  <p:cmAuthor id="1" name="David Morgan" initials="" lastIdx="1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 varScale="1">
        <p:scale>
          <a:sx n="163" d="100"/>
          <a:sy n="163" d="100"/>
        </p:scale>
        <p:origin x="-112" y="-7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commentAuthors" Target="commentAuthors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AFDC8-62C9-4B07-B2D8-B3E6344FDA0F}" type="datetimeFigureOut">
              <a:rPr lang="en-GB" smtClean="0"/>
              <a:pPr/>
              <a:t>18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70FFAD-E79E-4080-8957-828470D24EB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AFDC8-62C9-4B07-B2D8-B3E6344FDA0F}" type="datetimeFigureOut">
              <a:rPr lang="en-GB" smtClean="0"/>
              <a:pPr/>
              <a:t>18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70FFAD-E79E-4080-8957-828470D24EB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AFDC8-62C9-4B07-B2D8-B3E6344FDA0F}" type="datetimeFigureOut">
              <a:rPr lang="en-GB" smtClean="0"/>
              <a:pPr/>
              <a:t>18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70FFAD-E79E-4080-8957-828470D24EB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AFDC8-62C9-4B07-B2D8-B3E6344FDA0F}" type="datetimeFigureOut">
              <a:rPr lang="en-GB" smtClean="0"/>
              <a:pPr/>
              <a:t>18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70FFAD-E79E-4080-8957-828470D24EB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5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AFDC8-62C9-4B07-B2D8-B3E6344FDA0F}" type="datetimeFigureOut">
              <a:rPr lang="en-GB" smtClean="0"/>
              <a:pPr/>
              <a:t>18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70FFAD-E79E-4080-8957-828470D24EB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AFDC8-62C9-4B07-B2D8-B3E6344FDA0F}" type="datetimeFigureOut">
              <a:rPr lang="en-GB" smtClean="0"/>
              <a:pPr/>
              <a:t>18/09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70FFAD-E79E-4080-8957-828470D24EB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2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2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AFDC8-62C9-4B07-B2D8-B3E6344FDA0F}" type="datetimeFigureOut">
              <a:rPr lang="en-GB" smtClean="0"/>
              <a:pPr/>
              <a:t>18/09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70FFAD-E79E-4080-8957-828470D24EB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AFDC8-62C9-4B07-B2D8-B3E6344FDA0F}" type="datetimeFigureOut">
              <a:rPr lang="en-GB" smtClean="0"/>
              <a:pPr/>
              <a:t>18/09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70FFAD-E79E-4080-8957-828470D24EB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AFDC8-62C9-4B07-B2D8-B3E6344FDA0F}" type="datetimeFigureOut">
              <a:rPr lang="en-GB" smtClean="0"/>
              <a:pPr/>
              <a:t>18/09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70FFAD-E79E-4080-8957-828470D24EB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1" y="273052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2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AFDC8-62C9-4B07-B2D8-B3E6344FDA0F}" type="datetimeFigureOut">
              <a:rPr lang="en-GB" smtClean="0"/>
              <a:pPr/>
              <a:t>18/09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70FFAD-E79E-4080-8957-828470D24EB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AFDC8-62C9-4B07-B2D8-B3E6344FDA0F}" type="datetimeFigureOut">
              <a:rPr lang="en-GB" smtClean="0"/>
              <a:pPr/>
              <a:t>18/09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70FFAD-E79E-4080-8957-828470D24EB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2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2AFDC8-62C9-4B07-B2D8-B3E6344FDA0F}" type="datetimeFigureOut">
              <a:rPr lang="en-GB" smtClean="0"/>
              <a:pPr/>
              <a:t>18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70FFAD-E79E-4080-8957-828470D24EBC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Text Box 93"/>
          <p:cNvSpPr txBox="1">
            <a:spLocks noChangeArrowheads="1"/>
          </p:cNvSpPr>
          <p:nvPr/>
        </p:nvSpPr>
        <p:spPr bwMode="auto">
          <a:xfrm>
            <a:off x="720000" y="274385"/>
            <a:ext cx="416063" cy="2990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lIns="113302" tIns="56652" rIns="113302" bIns="56652">
            <a:spAutoFit/>
          </a:bodyPr>
          <a:lstStyle/>
          <a:p>
            <a:pPr defTabSz="1133675"/>
            <a:r>
              <a:rPr lang="en-GB" sz="1200" b="1" dirty="0">
                <a:latin typeface="Arial" pitchFamily="34" charset="0"/>
                <a:cs typeface="Arial" pitchFamily="34" charset="0"/>
              </a:rPr>
              <a:t>A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58" name="Picture 98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463955" y="823268"/>
            <a:ext cx="1345986" cy="117181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9" name="Picture 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379331" y="827059"/>
            <a:ext cx="1344797" cy="11680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0" name="Text Box 9"/>
          <p:cNvSpPr txBox="1">
            <a:spLocks noChangeArrowheads="1"/>
          </p:cNvSpPr>
          <p:nvPr/>
        </p:nvSpPr>
        <p:spPr bwMode="auto">
          <a:xfrm>
            <a:off x="4602451" y="1988840"/>
            <a:ext cx="1265693" cy="3365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Un-infected</a:t>
            </a:r>
            <a:endParaRPr lang="en-US" sz="11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61" name="Picture 5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2927903" y="820811"/>
            <a:ext cx="1384390" cy="11680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2" name="Text Box 6"/>
          <p:cNvSpPr txBox="1">
            <a:spLocks noChangeArrowheads="1"/>
          </p:cNvSpPr>
          <p:nvPr/>
        </p:nvSpPr>
        <p:spPr bwMode="auto">
          <a:xfrm>
            <a:off x="3269789" y="1988840"/>
            <a:ext cx="870163" cy="3365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Vac-WR</a:t>
            </a:r>
            <a:endParaRPr 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3" name="Text Box 99"/>
          <p:cNvSpPr txBox="1">
            <a:spLocks noChangeArrowheads="1"/>
          </p:cNvSpPr>
          <p:nvPr/>
        </p:nvSpPr>
        <p:spPr bwMode="auto">
          <a:xfrm>
            <a:off x="3245082" y="332656"/>
            <a:ext cx="1067211" cy="3780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lIns="123436" tIns="61719" rIns="123436" bIns="61719">
            <a:spAutoFit/>
          </a:bodyPr>
          <a:lstStyle/>
          <a:p>
            <a:pPr defTabSz="1133675"/>
            <a:r>
              <a:rPr lang="en-GB" sz="1100" dirty="0" smtClean="0">
                <a:latin typeface="Arial" pitchFamily="34" charset="0"/>
                <a:cs typeface="Arial" pitchFamily="34" charset="0"/>
              </a:rPr>
              <a:t>B2-1 cells </a:t>
            </a:r>
            <a:endParaRPr 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0" name="Text Box 6"/>
          <p:cNvSpPr txBox="1">
            <a:spLocks noChangeArrowheads="1"/>
          </p:cNvSpPr>
          <p:nvPr/>
        </p:nvSpPr>
        <p:spPr bwMode="auto">
          <a:xfrm>
            <a:off x="1647997" y="1988840"/>
            <a:ext cx="1186585" cy="3365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Vac-LMP2A</a:t>
            </a:r>
            <a:endParaRPr lang="en-US" sz="11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6" name="Straight Connector 65"/>
          <p:cNvCxnSpPr/>
          <p:nvPr/>
        </p:nvCxnSpPr>
        <p:spPr>
          <a:xfrm>
            <a:off x="1689737" y="608053"/>
            <a:ext cx="38761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7" name="Straight Connector 66"/>
          <p:cNvCxnSpPr/>
          <p:nvPr/>
        </p:nvCxnSpPr>
        <p:spPr>
          <a:xfrm rot="5400000">
            <a:off x="5492989" y="681055"/>
            <a:ext cx="14600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8" name="Straight Connector 67"/>
          <p:cNvCxnSpPr/>
          <p:nvPr/>
        </p:nvCxnSpPr>
        <p:spPr>
          <a:xfrm rot="5400000">
            <a:off x="3591219" y="681055"/>
            <a:ext cx="14600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9" name="Straight Connector 68"/>
          <p:cNvCxnSpPr/>
          <p:nvPr/>
        </p:nvCxnSpPr>
        <p:spPr>
          <a:xfrm rot="5400000">
            <a:off x="1624479" y="681055"/>
            <a:ext cx="14600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5" name="Rectangle 74"/>
          <p:cNvSpPr/>
          <p:nvPr/>
        </p:nvSpPr>
        <p:spPr>
          <a:xfrm>
            <a:off x="749323" y="4840946"/>
            <a:ext cx="7711109" cy="185563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GB" sz="1100" b="1" dirty="0">
                <a:latin typeface="Arial" pitchFamily="34" charset="0"/>
                <a:cs typeface="Arial" pitchFamily="34" charset="0"/>
              </a:rPr>
              <a:t>Supplementary </a:t>
            </a:r>
            <a:r>
              <a:rPr lang="en-GB" sz="1100" b="1" dirty="0" smtClean="0">
                <a:latin typeface="Arial" pitchFamily="34" charset="0"/>
                <a:cs typeface="Arial" pitchFamily="34" charset="0"/>
              </a:rPr>
              <a:t>Figure 1.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mmunization of BALB/c to generate LMP2A-specific CTLs</a:t>
            </a:r>
          </a:p>
          <a:p>
            <a:pPr algn="just">
              <a:lnSpc>
                <a:spcPct val="150000"/>
              </a:lnSpc>
            </a:pP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Monolayers of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B2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1 cells were infected with recombinant vaccinia virus Vac-LMP2A or wild type vaccinia virus Vac-WR for 16 hours at a multiplicity of infection (MOI) of 10.  Confocal immune-fluorescence images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how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MP2A expression in green and DAPI staining of the nucleus in blue. 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BALB/c mice were immunized with 2 x 10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p.f.u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of Vac-LMP2A or Vac-WR.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wo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weeks after immunization, splenocytes were harvested and tested for production of IFN-γ and IL-2 after overnight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ex-vivo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re-stimulation with irradiated B2-1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ells that were: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u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nfected,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Vac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LMP2A-infected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or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ac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WR infected;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s APCs.  A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x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hour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timulation of uninfected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plenocytes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with with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on-A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lone was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used as a positive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ontrol.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6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5730902" y="3240040"/>
            <a:ext cx="1675432" cy="16291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Rectangle 3"/>
          <p:cNvSpPr/>
          <p:nvPr/>
        </p:nvSpPr>
        <p:spPr>
          <a:xfrm>
            <a:off x="7052546" y="3577750"/>
            <a:ext cx="220920" cy="12964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3657519" y="3515762"/>
            <a:ext cx="220920" cy="12964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2921119" y="3515762"/>
            <a:ext cx="147280" cy="12964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3878439" y="4358433"/>
            <a:ext cx="147280" cy="12964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2479279" y="4358433"/>
            <a:ext cx="147280" cy="12964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874094" y="3550876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 pitchFamily="34" charset="0"/>
                <a:cs typeface="Arial" pitchFamily="34" charset="0"/>
              </a:rPr>
              <a:t>0.1</a:t>
            </a:r>
            <a:endParaRPr lang="en-GB" sz="9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" name="Picture 7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3912353" y="3195715"/>
            <a:ext cx="1692000" cy="16452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1" name="Picture 4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2479279" y="3191657"/>
            <a:ext cx="1675432" cy="16291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2" name="TextBox 11"/>
          <p:cNvSpPr txBox="1"/>
          <p:nvPr/>
        </p:nvSpPr>
        <p:spPr>
          <a:xfrm>
            <a:off x="3628219" y="4255252"/>
            <a:ext cx="409086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 pitchFamily="34" charset="0"/>
                <a:cs typeface="Arial" pitchFamily="34" charset="0"/>
              </a:rPr>
              <a:t>0.73</a:t>
            </a:r>
            <a:endParaRPr lang="en-GB" sz="9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6" name="Straight Connector 45"/>
          <p:cNvCxnSpPr/>
          <p:nvPr/>
        </p:nvCxnSpPr>
        <p:spPr>
          <a:xfrm>
            <a:off x="1666219" y="3096000"/>
            <a:ext cx="36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" name="Straight Connector 46"/>
          <p:cNvCxnSpPr/>
          <p:nvPr/>
        </p:nvCxnSpPr>
        <p:spPr>
          <a:xfrm rot="5400000">
            <a:off x="5284219" y="3152750"/>
            <a:ext cx="1135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" name="Straight Connector 47"/>
          <p:cNvCxnSpPr/>
          <p:nvPr/>
        </p:nvCxnSpPr>
        <p:spPr>
          <a:xfrm rot="5400000">
            <a:off x="1615819" y="3152750"/>
            <a:ext cx="1135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Rectangle 13"/>
          <p:cNvSpPr/>
          <p:nvPr/>
        </p:nvSpPr>
        <p:spPr>
          <a:xfrm>
            <a:off x="6151561" y="3572246"/>
            <a:ext cx="257914" cy="12964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4348219" y="3528000"/>
            <a:ext cx="147280" cy="12964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6" name="Picture 5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1139112" y="3191657"/>
            <a:ext cx="1675432" cy="16291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pSp>
        <p:nvGrpSpPr>
          <p:cNvPr id="17" name="Group 16"/>
          <p:cNvGrpSpPr/>
          <p:nvPr/>
        </p:nvGrpSpPr>
        <p:grpSpPr>
          <a:xfrm>
            <a:off x="1180219" y="3564000"/>
            <a:ext cx="1272672" cy="1258000"/>
            <a:chOff x="492625" y="2866152"/>
            <a:chExt cx="1272672" cy="1258000"/>
          </a:xfrm>
        </p:grpSpPr>
        <p:sp>
          <p:nvSpPr>
            <p:cNvPr id="42" name="Text Box 82"/>
            <p:cNvSpPr txBox="1">
              <a:spLocks noChangeArrowheads="1"/>
            </p:cNvSpPr>
            <p:nvPr/>
          </p:nvSpPr>
          <p:spPr bwMode="auto">
            <a:xfrm>
              <a:off x="1058291" y="3814843"/>
              <a:ext cx="707006" cy="30930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 lIns="123436" tIns="61719" rIns="123436" bIns="61719">
              <a:spAutoFit/>
            </a:bodyPr>
            <a:lstStyle/>
            <a:p>
              <a:pPr defTabSz="1133675"/>
              <a:r>
                <a:rPr lang="en-GB" sz="1200" dirty="0">
                  <a:latin typeface="Arial" pitchFamily="34" charset="0"/>
                  <a:cs typeface="Arial" pitchFamily="34" charset="0"/>
                </a:rPr>
                <a:t>IL-2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" name="Text Box 83"/>
            <p:cNvSpPr txBox="1">
              <a:spLocks noChangeArrowheads="1"/>
            </p:cNvSpPr>
            <p:nvPr/>
          </p:nvSpPr>
          <p:spPr bwMode="auto">
            <a:xfrm rot="16200000">
              <a:off x="332516" y="3026261"/>
              <a:ext cx="629527" cy="30930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 lIns="123436" tIns="61719" rIns="123436" bIns="61719">
              <a:spAutoFit/>
            </a:bodyPr>
            <a:lstStyle/>
            <a:p>
              <a:pPr defTabSz="1133675"/>
              <a:r>
                <a:rPr lang="en-GB" sz="1200" dirty="0">
                  <a:latin typeface="Arial" pitchFamily="34" charset="0"/>
                  <a:cs typeface="Arial" pitchFamily="34" charset="0"/>
                </a:rPr>
                <a:t>IFN-</a:t>
              </a:r>
              <a:r>
                <a:rPr lang="el-GR" sz="1200" dirty="0">
                  <a:latin typeface="Arial" pitchFamily="34" charset="0"/>
                  <a:cs typeface="Arial" pitchFamily="34" charset="0"/>
                </a:rPr>
                <a:t>γ</a:t>
              </a:r>
            </a:p>
          </p:txBody>
        </p:sp>
        <p:cxnSp>
          <p:nvCxnSpPr>
            <p:cNvPr id="44" name="Straight Arrow Connector 43"/>
            <p:cNvCxnSpPr/>
            <p:nvPr/>
          </p:nvCxnSpPr>
          <p:spPr>
            <a:xfrm rot="5400000" flipH="1" flipV="1">
              <a:off x="411025" y="3741296"/>
              <a:ext cx="437660" cy="1578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5" name="Straight Arrow Connector 44"/>
            <p:cNvCxnSpPr/>
            <p:nvPr/>
          </p:nvCxnSpPr>
          <p:spPr>
            <a:xfrm>
              <a:off x="629066" y="3960914"/>
              <a:ext cx="429225" cy="1609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8" name="Rectangle 17"/>
          <p:cNvSpPr/>
          <p:nvPr/>
        </p:nvSpPr>
        <p:spPr>
          <a:xfrm>
            <a:off x="2292301" y="3528000"/>
            <a:ext cx="220920" cy="12964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2402761" y="4347066"/>
            <a:ext cx="220920" cy="12964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Rectangle 19"/>
          <p:cNvSpPr/>
          <p:nvPr/>
        </p:nvSpPr>
        <p:spPr>
          <a:xfrm>
            <a:off x="1559058" y="3528000"/>
            <a:ext cx="147280" cy="12964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Rectangle 20"/>
          <p:cNvSpPr/>
          <p:nvPr/>
        </p:nvSpPr>
        <p:spPr>
          <a:xfrm>
            <a:off x="2908219" y="3504683"/>
            <a:ext cx="220920" cy="12964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Rectangle 21"/>
          <p:cNvSpPr/>
          <p:nvPr/>
        </p:nvSpPr>
        <p:spPr>
          <a:xfrm>
            <a:off x="3731159" y="3528000"/>
            <a:ext cx="220920" cy="12964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Rectangle 22"/>
          <p:cNvSpPr/>
          <p:nvPr/>
        </p:nvSpPr>
        <p:spPr>
          <a:xfrm>
            <a:off x="5227554" y="3580583"/>
            <a:ext cx="220920" cy="12964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Rectangle 23"/>
          <p:cNvSpPr/>
          <p:nvPr/>
        </p:nvSpPr>
        <p:spPr>
          <a:xfrm>
            <a:off x="5266219" y="4355898"/>
            <a:ext cx="220920" cy="12964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Rectangle 24"/>
          <p:cNvSpPr/>
          <p:nvPr/>
        </p:nvSpPr>
        <p:spPr>
          <a:xfrm>
            <a:off x="7059059" y="4367908"/>
            <a:ext cx="220920" cy="12964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548000" y="3468314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 pitchFamily="34" charset="0"/>
                <a:cs typeface="Arial" pitchFamily="34" charset="0"/>
              </a:rPr>
              <a:t>0.15</a:t>
            </a:r>
            <a:endParaRPr lang="en-GB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292301" y="3499445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 pitchFamily="34" charset="0"/>
                <a:cs typeface="Arial" pitchFamily="34" charset="0"/>
              </a:rPr>
              <a:t>0.00</a:t>
            </a:r>
            <a:endParaRPr lang="en-GB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2263853" y="4258472"/>
            <a:ext cx="409086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 pitchFamily="34" charset="0"/>
                <a:cs typeface="Arial" pitchFamily="34" charset="0"/>
              </a:rPr>
              <a:t>0.19</a:t>
            </a:r>
            <a:endParaRPr lang="en-GB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2863856" y="3479393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 pitchFamily="34" charset="0"/>
                <a:cs typeface="Arial" pitchFamily="34" charset="0"/>
              </a:rPr>
              <a:t>0.18</a:t>
            </a:r>
            <a:endParaRPr lang="en-GB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705956" y="3490503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 pitchFamily="34" charset="0"/>
                <a:cs typeface="Arial" pitchFamily="34" charset="0"/>
              </a:rPr>
              <a:t>0.1</a:t>
            </a:r>
            <a:endParaRPr lang="en-GB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6101878" y="3512929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 pitchFamily="34" charset="0"/>
                <a:cs typeface="Arial" pitchFamily="34" charset="0"/>
              </a:rPr>
              <a:t>0.23</a:t>
            </a:r>
            <a:endParaRPr lang="en-GB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6848003" y="4328246"/>
            <a:ext cx="409086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 pitchFamily="34" charset="0"/>
                <a:cs typeface="Arial" pitchFamily="34" charset="0"/>
              </a:rPr>
              <a:t>0.81</a:t>
            </a:r>
            <a:endParaRPr lang="en-GB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4308357" y="3479393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 pitchFamily="34" charset="0"/>
                <a:cs typeface="Arial" pitchFamily="34" charset="0"/>
              </a:rPr>
              <a:t>9.28</a:t>
            </a:r>
            <a:endParaRPr lang="en-GB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5104219" y="4284000"/>
            <a:ext cx="409086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 pitchFamily="34" charset="0"/>
                <a:cs typeface="Arial" pitchFamily="34" charset="0"/>
              </a:rPr>
              <a:t>1.01</a:t>
            </a:r>
            <a:endParaRPr lang="en-GB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5018710" y="3518909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 pitchFamily="34" charset="0"/>
                <a:cs typeface="Arial" pitchFamily="34" charset="0"/>
              </a:rPr>
              <a:t>0.76</a:t>
            </a:r>
            <a:endParaRPr lang="en-GB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Rectangle 35"/>
          <p:cNvSpPr/>
          <p:nvPr/>
        </p:nvSpPr>
        <p:spPr>
          <a:xfrm>
            <a:off x="1043609" y="2844000"/>
            <a:ext cx="432047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 smtClean="0">
                <a:latin typeface="Arial" pitchFamily="34" charset="0"/>
                <a:cs typeface="Arial" pitchFamily="34" charset="0"/>
              </a:rPr>
              <a:t>Mice:	              Vac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-LMP2A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immunized</a:t>
            </a:r>
            <a:endParaRPr lang="en-GB" sz="1200" dirty="0"/>
          </a:p>
        </p:txBody>
      </p:sp>
      <p:sp>
        <p:nvSpPr>
          <p:cNvPr id="37" name="Rectangle 36"/>
          <p:cNvSpPr/>
          <p:nvPr/>
        </p:nvSpPr>
        <p:spPr>
          <a:xfrm>
            <a:off x="5994935" y="2852246"/>
            <a:ext cx="152939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 smtClean="0">
                <a:latin typeface="Arial" pitchFamily="34" charset="0"/>
                <a:cs typeface="Arial" pitchFamily="34" charset="0"/>
              </a:rPr>
              <a:t>Vac-WR 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immunized</a:t>
            </a:r>
            <a:endParaRPr lang="en-GB" sz="1200" dirty="0"/>
          </a:p>
        </p:txBody>
      </p:sp>
      <p:sp>
        <p:nvSpPr>
          <p:cNvPr id="38" name="Rectangle 37"/>
          <p:cNvSpPr/>
          <p:nvPr/>
        </p:nvSpPr>
        <p:spPr>
          <a:xfrm>
            <a:off x="899592" y="3212976"/>
            <a:ext cx="2016224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  B21 cells:   u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nfected 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 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Rectangle 38"/>
          <p:cNvSpPr/>
          <p:nvPr/>
        </p:nvSpPr>
        <p:spPr>
          <a:xfrm>
            <a:off x="2731254" y="3212976"/>
            <a:ext cx="148070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Vac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LMP2A-infected 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Rectangle 39"/>
          <p:cNvSpPr/>
          <p:nvPr/>
        </p:nvSpPr>
        <p:spPr>
          <a:xfrm>
            <a:off x="4283968" y="3212976"/>
            <a:ext cx="1284539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ac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WR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nfected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Rectangle 40"/>
          <p:cNvSpPr/>
          <p:nvPr/>
        </p:nvSpPr>
        <p:spPr>
          <a:xfrm>
            <a:off x="6438061" y="3221222"/>
            <a:ext cx="58221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sz="1100" dirty="0" smtClean="0">
                <a:latin typeface="Arial" pitchFamily="34" charset="0"/>
                <a:cs typeface="Arial" pitchFamily="34" charset="0"/>
              </a:rPr>
              <a:t>Con A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6" name="Text Box 93"/>
          <p:cNvSpPr txBox="1">
            <a:spLocks noChangeArrowheads="1"/>
          </p:cNvSpPr>
          <p:nvPr/>
        </p:nvSpPr>
        <p:spPr bwMode="auto">
          <a:xfrm>
            <a:off x="720000" y="2880000"/>
            <a:ext cx="416063" cy="2990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lIns="113302" tIns="56652" rIns="113302" bIns="56652">
            <a:spAutoFit/>
          </a:bodyPr>
          <a:lstStyle/>
          <a:p>
            <a:pPr defTabSz="1133675"/>
            <a:r>
              <a:rPr lang="en-GB" sz="1200" b="1" dirty="0" smtClean="0">
                <a:latin typeface="Arial" pitchFamily="34" charset="0"/>
                <a:cs typeface="Arial" pitchFamily="34" charset="0"/>
              </a:rPr>
              <a:t>B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7" name="Straight Connector 76"/>
          <p:cNvCxnSpPr/>
          <p:nvPr/>
        </p:nvCxnSpPr>
        <p:spPr>
          <a:xfrm rot="5400000">
            <a:off x="3435130" y="3156226"/>
            <a:ext cx="1135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5818712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33</TotalTime>
  <Words>230</Words>
  <Application>Microsoft Macintosh PowerPoint</Application>
  <PresentationFormat>On-screen Show (4:3)</PresentationFormat>
  <Paragraphs>2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eatrice</dc:creator>
  <cp:lastModifiedBy>David</cp:lastModifiedBy>
  <cp:revision>70</cp:revision>
  <dcterms:created xsi:type="dcterms:W3CDTF">2011-07-27T10:29:39Z</dcterms:created>
  <dcterms:modified xsi:type="dcterms:W3CDTF">2014-09-18T15:36:46Z</dcterms:modified>
</cp:coreProperties>
</file>